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9" r:id="rId2"/>
    <p:sldId id="256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880" autoAdjust="0"/>
  </p:normalViewPr>
  <p:slideViewPr>
    <p:cSldViewPr snapToGrid="0">
      <p:cViewPr varScale="1">
        <p:scale>
          <a:sx n="147" d="100"/>
          <a:sy n="147" d="100"/>
        </p:scale>
        <p:origin x="1448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yk Barseghyan" userId="1af3c995-31f7-415e-9aa1-2b36900e994d" providerId="ADAL" clId="{2A48D2A3-30B8-49AA-8B02-7FA3769BEEF6}"/>
    <pc:docChg chg="delSld">
      <pc:chgData name="Hayk Barseghyan" userId="1af3c995-31f7-415e-9aa1-2b36900e994d" providerId="ADAL" clId="{2A48D2A3-30B8-49AA-8B02-7FA3769BEEF6}" dt="2021-06-25T18:47:07.927" v="0" actId="47"/>
      <pc:docMkLst>
        <pc:docMk/>
      </pc:docMkLst>
      <pc:sldChg chg="del">
        <pc:chgData name="Hayk Barseghyan" userId="1af3c995-31f7-415e-9aa1-2b36900e994d" providerId="ADAL" clId="{2A48D2A3-30B8-49AA-8B02-7FA3769BEEF6}" dt="2021-06-25T18:47:07.927" v="0" actId="47"/>
        <pc:sldMkLst>
          <pc:docMk/>
          <pc:sldMk cId="3819067561" sldId="257"/>
        </pc:sldMkLst>
      </pc:sldChg>
    </pc:docChg>
  </pc:docChgLst>
  <pc:docChgLst>
    <pc:chgData name="Ben Clifford" userId="S::bclifford@bionanogenomics.com::37190262-3d35-4585-9cd0-592803b01aba" providerId="AD" clId="Web-{66A1A6AF-3BD8-1722-62E1-420265C2794C}"/>
    <pc:docChg chg="addSld modSld">
      <pc:chgData name="Ben Clifford" userId="S::bclifford@bionanogenomics.com::37190262-3d35-4585-9cd0-592803b01aba" providerId="AD" clId="Web-{66A1A6AF-3BD8-1722-62E1-420265C2794C}" dt="2021-09-28T18:22:12.520" v="5" actId="1076"/>
      <pc:docMkLst>
        <pc:docMk/>
      </pc:docMkLst>
      <pc:sldChg chg="addSp modSp new">
        <pc:chgData name="Ben Clifford" userId="S::bclifford@bionanogenomics.com::37190262-3d35-4585-9cd0-592803b01aba" providerId="AD" clId="Web-{66A1A6AF-3BD8-1722-62E1-420265C2794C}" dt="2021-09-28T18:22:12.520" v="5" actId="1076"/>
        <pc:sldMkLst>
          <pc:docMk/>
          <pc:sldMk cId="3539422222" sldId="259"/>
        </pc:sldMkLst>
        <pc:picChg chg="add mod">
          <ac:chgData name="Ben Clifford" userId="S::bclifford@bionanogenomics.com::37190262-3d35-4585-9cd0-592803b01aba" providerId="AD" clId="Web-{66A1A6AF-3BD8-1722-62E1-420265C2794C}" dt="2021-09-28T18:22:12.520" v="5" actId="1076"/>
          <ac:picMkLst>
            <pc:docMk/>
            <pc:sldMk cId="3539422222" sldId="259"/>
            <ac:picMk id="2" creationId="{912B2AF7-6B47-4FEC-B9E3-220847E8BEC1}"/>
          </ac:picMkLst>
        </pc:picChg>
      </pc:sldChg>
    </pc:docChg>
  </pc:docChgLst>
  <pc:docChgLst>
    <pc:chgData name="Hayk Barseghyan" userId="1af3c995-31f7-415e-9aa1-2b36900e994d" providerId="ADAL" clId="{D0E42CDB-7071-48AD-BAA0-21E04B3B199D}"/>
    <pc:docChg chg="undo custSel modSld">
      <pc:chgData name="Hayk Barseghyan" userId="1af3c995-31f7-415e-9aa1-2b36900e994d" providerId="ADAL" clId="{D0E42CDB-7071-48AD-BAA0-21E04B3B199D}" dt="2021-12-22T20:53:25.598" v="8" actId="1076"/>
      <pc:docMkLst>
        <pc:docMk/>
      </pc:docMkLst>
      <pc:sldChg chg="addSp delSp modSp mod">
        <pc:chgData name="Hayk Barseghyan" userId="1af3c995-31f7-415e-9aa1-2b36900e994d" providerId="ADAL" clId="{D0E42CDB-7071-48AD-BAA0-21E04B3B199D}" dt="2021-12-22T20:53:25.598" v="8" actId="1076"/>
        <pc:sldMkLst>
          <pc:docMk/>
          <pc:sldMk cId="3539422222" sldId="259"/>
        </pc:sldMkLst>
        <pc:spChg chg="del">
          <ac:chgData name="Hayk Barseghyan" userId="1af3c995-31f7-415e-9aa1-2b36900e994d" providerId="ADAL" clId="{D0E42CDB-7071-48AD-BAA0-21E04B3B199D}" dt="2021-12-22T20:48:53.157" v="0" actId="478"/>
          <ac:spMkLst>
            <pc:docMk/>
            <pc:sldMk cId="3539422222" sldId="259"/>
            <ac:spMk id="5" creationId="{BC49680E-3DC6-40D4-9913-C2B95E0E2A36}"/>
          </ac:spMkLst>
        </pc:spChg>
        <pc:picChg chg="add del mod">
          <ac:chgData name="Hayk Barseghyan" userId="1af3c995-31f7-415e-9aa1-2b36900e994d" providerId="ADAL" clId="{D0E42CDB-7071-48AD-BAA0-21E04B3B199D}" dt="2021-12-22T20:53:25.598" v="8" actId="1076"/>
          <ac:picMkLst>
            <pc:docMk/>
            <pc:sldMk cId="3539422222" sldId="259"/>
            <ac:picMk id="2" creationId="{912B2AF7-6B47-4FEC-B9E3-220847E8BEC1}"/>
          </ac:picMkLst>
        </pc:picChg>
        <pc:picChg chg="add mod">
          <ac:chgData name="Hayk Barseghyan" userId="1af3c995-31f7-415e-9aa1-2b36900e994d" providerId="ADAL" clId="{D0E42CDB-7071-48AD-BAA0-21E04B3B199D}" dt="2021-12-22T20:53:25.598" v="8" actId="1076"/>
          <ac:picMkLst>
            <pc:docMk/>
            <pc:sldMk cId="3539422222" sldId="259"/>
            <ac:picMk id="6" creationId="{4AF4643D-6700-4307-A458-83A6E62D22DD}"/>
          </ac:picMkLst>
        </pc:picChg>
      </pc:sldChg>
    </pc:docChg>
  </pc:docChgLst>
  <pc:docChgLst>
    <pc:chgData name="Hayk Barseghyan" userId="1af3c995-31f7-415e-9aa1-2b36900e994d" providerId="ADAL" clId="{ED5DE36B-BEF7-40ED-B085-8D188486DD58}"/>
    <pc:docChg chg="modSld">
      <pc:chgData name="Hayk Barseghyan" userId="1af3c995-31f7-415e-9aa1-2b36900e994d" providerId="ADAL" clId="{ED5DE36B-BEF7-40ED-B085-8D188486DD58}" dt="2021-07-23T18:50:13.649" v="1" actId="20577"/>
      <pc:docMkLst>
        <pc:docMk/>
      </pc:docMkLst>
      <pc:sldChg chg="modSp mod">
        <pc:chgData name="Hayk Barseghyan" userId="1af3c995-31f7-415e-9aa1-2b36900e994d" providerId="ADAL" clId="{ED5DE36B-BEF7-40ED-B085-8D188486DD58}" dt="2021-07-23T18:50:13.649" v="1" actId="20577"/>
        <pc:sldMkLst>
          <pc:docMk/>
          <pc:sldMk cId="2619879681" sldId="258"/>
        </pc:sldMkLst>
        <pc:graphicFrameChg chg="modGraphic">
          <ac:chgData name="Hayk Barseghyan" userId="1af3c995-31f7-415e-9aa1-2b36900e994d" providerId="ADAL" clId="{ED5DE36B-BEF7-40ED-B085-8D188486DD58}" dt="2021-07-23T18:50:13.649" v="1" actId="20577"/>
          <ac:graphicFrameMkLst>
            <pc:docMk/>
            <pc:sldMk cId="2619879681" sldId="258"/>
            <ac:graphicFrameMk id="10" creationId="{B25344F3-3DC1-43AD-AB61-6BE0F42F86E3}"/>
          </ac:graphicFrameMkLst>
        </pc:graphicFrameChg>
      </pc:sldChg>
    </pc:docChg>
  </pc:docChgLst>
  <pc:docChgLst>
    <pc:chgData name="Hayk Barseghyan" userId="1af3c995-31f7-415e-9aa1-2b36900e994d" providerId="ADAL" clId="{FB3F42C5-E5D9-46AF-B889-769C63409625}"/>
    <pc:docChg chg="modSld sldOrd">
      <pc:chgData name="Hayk Barseghyan" userId="1af3c995-31f7-415e-9aa1-2b36900e994d" providerId="ADAL" clId="{FB3F42C5-E5D9-46AF-B889-769C63409625}" dt="2021-11-15T18:40:33.460" v="70" actId="20577"/>
      <pc:docMkLst>
        <pc:docMk/>
      </pc:docMkLst>
      <pc:sldChg chg="addSp modSp mod modNotesTx">
        <pc:chgData name="Hayk Barseghyan" userId="1af3c995-31f7-415e-9aa1-2b36900e994d" providerId="ADAL" clId="{FB3F42C5-E5D9-46AF-B889-769C63409625}" dt="2021-11-15T18:40:29.915" v="68" actId="20577"/>
        <pc:sldMkLst>
          <pc:docMk/>
          <pc:sldMk cId="1289568086" sldId="256"/>
        </pc:sldMkLst>
        <pc:spChg chg="add mod">
          <ac:chgData name="Hayk Barseghyan" userId="1af3c995-31f7-415e-9aa1-2b36900e994d" providerId="ADAL" clId="{FB3F42C5-E5D9-46AF-B889-769C63409625}" dt="2021-11-15T18:40:29.915" v="68" actId="20577"/>
          <ac:spMkLst>
            <pc:docMk/>
            <pc:sldMk cId="1289568086" sldId="256"/>
            <ac:spMk id="5" creationId="{F3595337-F626-490A-BB65-80C23B30DA22}"/>
          </ac:spMkLst>
        </pc:spChg>
      </pc:sldChg>
      <pc:sldChg chg="addSp modSp mod modNotesTx">
        <pc:chgData name="Hayk Barseghyan" userId="1af3c995-31f7-415e-9aa1-2b36900e994d" providerId="ADAL" clId="{FB3F42C5-E5D9-46AF-B889-769C63409625}" dt="2021-11-15T18:40:33.460" v="70" actId="20577"/>
        <pc:sldMkLst>
          <pc:docMk/>
          <pc:sldMk cId="2619879681" sldId="258"/>
        </pc:sldMkLst>
        <pc:spChg chg="add mod">
          <ac:chgData name="Hayk Barseghyan" userId="1af3c995-31f7-415e-9aa1-2b36900e994d" providerId="ADAL" clId="{FB3F42C5-E5D9-46AF-B889-769C63409625}" dt="2021-11-15T18:40:33.460" v="70" actId="20577"/>
          <ac:spMkLst>
            <pc:docMk/>
            <pc:sldMk cId="2619879681" sldId="258"/>
            <ac:spMk id="22" creationId="{D273D20F-6BE9-46BE-B7AD-86A7044605F4}"/>
          </ac:spMkLst>
        </pc:spChg>
      </pc:sldChg>
      <pc:sldChg chg="addSp modSp mod ord modNotesTx">
        <pc:chgData name="Hayk Barseghyan" userId="1af3c995-31f7-415e-9aa1-2b36900e994d" providerId="ADAL" clId="{FB3F42C5-E5D9-46AF-B889-769C63409625}" dt="2021-11-15T18:40:09.666" v="63" actId="1076"/>
        <pc:sldMkLst>
          <pc:docMk/>
          <pc:sldMk cId="3539422222" sldId="259"/>
        </pc:sldMkLst>
        <pc:spChg chg="add mod">
          <ac:chgData name="Hayk Barseghyan" userId="1af3c995-31f7-415e-9aa1-2b36900e994d" providerId="ADAL" clId="{FB3F42C5-E5D9-46AF-B889-769C63409625}" dt="2021-11-15T18:39:09.583" v="14"/>
          <ac:spMkLst>
            <pc:docMk/>
            <pc:sldMk cId="3539422222" sldId="259"/>
            <ac:spMk id="3" creationId="{1180B8E1-C69C-4EA8-97D7-1F30389B7BBC}"/>
          </ac:spMkLst>
        </pc:spChg>
        <pc:spChg chg="add mod">
          <ac:chgData name="Hayk Barseghyan" userId="1af3c995-31f7-415e-9aa1-2b36900e994d" providerId="ADAL" clId="{FB3F42C5-E5D9-46AF-B889-769C63409625}" dt="2021-11-15T18:40:09.666" v="63" actId="1076"/>
          <ac:spMkLst>
            <pc:docMk/>
            <pc:sldMk cId="3539422222" sldId="259"/>
            <ac:spMk id="5" creationId="{BC49680E-3DC6-40D4-9913-C2B95E0E2A36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bionanowithcentrexit-my.sharepoint.com/personal/hbarseghyan_bionanogenomics_com/Documents/AlleleDx.BNG_Manuscript/AlleleDx.BNG_summary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bionanowithcentrexit-my.sharepoint.com/personal/hbarseghyan_bionanogenomics_com/Documents/AlleleDx.BNG_Manuscript/AlleleDx.BNG_summaryTab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20D-4855-B7D1-323675FF7D7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20D-4855-B7D1-323675FF7D7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20D-4855-B7D1-323675FF7D7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20D-4855-B7D1-323675FF7D7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20D-4855-B7D1-323675FF7D7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20D-4855-B7D1-323675FF7D7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V_summary_prePostSOP!$D$2:$I$2</c:f>
              <c:strCache>
                <c:ptCount val="6"/>
                <c:pt idx="0">
                  <c:v>Deletions                          </c:v>
                </c:pt>
                <c:pt idx="1">
                  <c:v>Duplications                       </c:v>
                </c:pt>
                <c:pt idx="2">
                  <c:v>Insertions                         </c:v>
                </c:pt>
                <c:pt idx="3">
                  <c:v>Inversion breakpoints              </c:v>
                </c:pt>
                <c:pt idx="4">
                  <c:v>Interchr. translocation breakpoints</c:v>
                </c:pt>
                <c:pt idx="5">
                  <c:v>Intrachr. translocation breakpoints</c:v>
                </c:pt>
              </c:strCache>
            </c:strRef>
          </c:cat>
          <c:val>
            <c:numRef>
              <c:f>SV_summary_prePostSOP!$D$56:$I$56</c:f>
              <c:numCache>
                <c:formatCode>#,##0.0</c:formatCode>
                <c:ptCount val="6"/>
                <c:pt idx="0">
                  <c:v>1304.5</c:v>
                </c:pt>
                <c:pt idx="1">
                  <c:v>42.17307692307692</c:v>
                </c:pt>
                <c:pt idx="2">
                  <c:v>2896.4423076923076</c:v>
                </c:pt>
                <c:pt idx="3">
                  <c:v>82.115384615384613</c:v>
                </c:pt>
                <c:pt idx="4">
                  <c:v>0.25</c:v>
                </c:pt>
                <c:pt idx="5">
                  <c:v>0.134615384615384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20D-4855-B7D1-323675FF7D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3F0-45A9-A790-1231051D77A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3F0-45A9-A790-1231051D77A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3F0-45A9-A790-1231051D77A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3F0-45A9-A790-1231051D77A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3F0-45A9-A790-1231051D77A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3F0-45A9-A790-1231051D77A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V_summary_prePostSOP!$K$2:$P$2</c:f>
              <c:strCache>
                <c:ptCount val="6"/>
                <c:pt idx="0">
                  <c:v>Filtered deletions                          </c:v>
                </c:pt>
                <c:pt idx="1">
                  <c:v>Filtered Duplications                       </c:v>
                </c:pt>
                <c:pt idx="2">
                  <c:v>Filtered Insertions                         </c:v>
                </c:pt>
                <c:pt idx="3">
                  <c:v>Filtered Inversion breakpoints              </c:v>
                </c:pt>
                <c:pt idx="4">
                  <c:v>Filtered Interchr. translocation breakpoints</c:v>
                </c:pt>
                <c:pt idx="5">
                  <c:v>Filtered Intrachr. translocation breakpoints</c:v>
                </c:pt>
              </c:strCache>
            </c:strRef>
          </c:cat>
          <c:val>
            <c:numRef>
              <c:f>SV_summary_prePostSOP!$K$56:$P$56</c:f>
              <c:numCache>
                <c:formatCode>0.0</c:formatCode>
                <c:ptCount val="6"/>
                <c:pt idx="0">
                  <c:v>7.7692307692307692</c:v>
                </c:pt>
                <c:pt idx="1">
                  <c:v>1.0961538461538463</c:v>
                </c:pt>
                <c:pt idx="2">
                  <c:v>5.134615384615385</c:v>
                </c:pt>
                <c:pt idx="3">
                  <c:v>2.8461538461538463</c:v>
                </c:pt>
                <c:pt idx="4">
                  <c:v>0.25</c:v>
                </c:pt>
                <c:pt idx="5">
                  <c:v>0.192307692307692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3F0-45A9-A790-1231051D77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76F142-B841-42CC-B1A9-A40D74EC9BE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90D017-4EBC-4CDC-9572-B1C8D6E59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887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0" dirty="0"/>
              <a:t>Figure S1: A typical diploid sample, VAF clusters around 0.5 (heterozygous ALT-REF) and 1.0 (homozygous ALT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90D017-4EBC-4CDC-9572-B1C8D6E59E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537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0" dirty="0"/>
              <a:t>Figure S1: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90D017-4EBC-4CDC-9572-B1C8D6E59E1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9103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0" dirty="0"/>
              <a:t>Figure S1: </a:t>
            </a:r>
            <a:endParaRPr lang="en-US" dirty="0"/>
          </a:p>
          <a:p>
            <a:r>
              <a:rPr lang="en-US" dirty="0"/>
              <a:t>Sample Allele 122</a:t>
            </a:r>
          </a:p>
          <a:p>
            <a:r>
              <a:rPr lang="en-US" dirty="0"/>
              <a:t>Bottom circos show the filter with MERGED morbid file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B4B41-3885-4BDE-8D92-E8E57CF9BC0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01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14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891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78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093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264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990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567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3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77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437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056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02336-2A80-44D6-A05C-1A97119C0AE8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A60A9-220B-4756-A75B-15D16BE531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730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picture containing calendar&#10;&#10;Description automatically generated">
            <a:extLst>
              <a:ext uri="{FF2B5EF4-FFF2-40B4-BE49-F238E27FC236}">
                <a16:creationId xmlns:a16="http://schemas.microsoft.com/office/drawing/2014/main" id="{912B2AF7-6B47-4FEC-B9E3-220847E8BE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37878"/>
            <a:ext cx="9144000" cy="10052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180B8E1-C69C-4EA8-97D7-1F30389B7BBC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A.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AF4643D-6700-4307-A458-83A6E62D22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28054"/>
            <a:ext cx="9144000" cy="858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9422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B6CEB0D6-6627-4160-85CF-56C7ECB730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5724046"/>
              </p:ext>
            </p:extLst>
          </p:nvPr>
        </p:nvGraphicFramePr>
        <p:xfrm>
          <a:off x="-76200" y="685800"/>
          <a:ext cx="5486400" cy="54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D32A9DB-1928-469F-850B-56B2C13DA9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0937747"/>
              </p:ext>
            </p:extLst>
          </p:nvPr>
        </p:nvGraphicFramePr>
        <p:xfrm>
          <a:off x="6138862" y="432435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D87C6007-D039-4236-A843-33C7DC27ACC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8368"/>
          <a:stretch/>
        </p:blipFill>
        <p:spPr>
          <a:xfrm>
            <a:off x="4309824" y="407504"/>
            <a:ext cx="5486876" cy="22868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595337-F626-490A-BB65-80C23B30DA22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9568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B5AD4A6-B494-40AD-8007-F668F865A9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560" y="3617818"/>
            <a:ext cx="3200400" cy="2986326"/>
          </a:xfrm>
          <a:prstGeom prst="ellipse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6B6C015-624A-497F-87B6-AF923F155C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560" y="209617"/>
            <a:ext cx="3200400" cy="3219383"/>
          </a:xfrm>
          <a:prstGeom prst="ellipse">
            <a:avLst/>
          </a:prstGeom>
        </p:spPr>
      </p:pic>
      <p:graphicFrame>
        <p:nvGraphicFramePr>
          <p:cNvPr id="10" name="Table 10">
            <a:extLst>
              <a:ext uri="{FF2B5EF4-FFF2-40B4-BE49-F238E27FC236}">
                <a16:creationId xmlns:a16="http://schemas.microsoft.com/office/drawing/2014/main" id="{B25344F3-3DC1-43AD-AB61-6BE0F42F86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4379919"/>
              </p:ext>
            </p:extLst>
          </p:nvPr>
        </p:nvGraphicFramePr>
        <p:xfrm>
          <a:off x="3864268" y="1555707"/>
          <a:ext cx="4928172" cy="296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74065">
                  <a:extLst>
                    <a:ext uri="{9D8B030D-6E8A-4147-A177-3AD203B41FA5}">
                      <a16:colId xmlns:a16="http://schemas.microsoft.com/office/drawing/2014/main" val="492578951"/>
                    </a:ext>
                  </a:extLst>
                </a:gridCol>
                <a:gridCol w="1011383">
                  <a:extLst>
                    <a:ext uri="{9D8B030D-6E8A-4147-A177-3AD203B41FA5}">
                      <a16:colId xmlns:a16="http://schemas.microsoft.com/office/drawing/2014/main" val="2532153086"/>
                    </a:ext>
                  </a:extLst>
                </a:gridCol>
                <a:gridCol w="1642724">
                  <a:extLst>
                    <a:ext uri="{9D8B030D-6E8A-4147-A177-3AD203B41FA5}">
                      <a16:colId xmlns:a16="http://schemas.microsoft.com/office/drawing/2014/main" val="30257067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/>
                        <a:t>Al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/>
                        <a:t>Post filter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883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Delet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13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0821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Duplicat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4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3058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Insert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288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8912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Invers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9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57566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err="1"/>
                        <a:t>Interchr</a:t>
                      </a:r>
                      <a:r>
                        <a:rPr lang="en-US" sz="1400"/>
                        <a:t> translocat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5545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err="1"/>
                        <a:t>Intrachr</a:t>
                      </a:r>
                      <a:r>
                        <a:rPr lang="en-US" sz="1400"/>
                        <a:t> translocatio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24208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/>
                        <a:t>Tota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433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7939023"/>
                  </a:ext>
                </a:extLst>
              </a:tr>
            </a:tbl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:a16="http://schemas.microsoft.com/office/drawing/2014/main" id="{44FD957E-825E-4EB7-AFAF-4F3A3A22698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876" t="84140" b="2491"/>
          <a:stretch/>
        </p:blipFill>
        <p:spPr>
          <a:xfrm>
            <a:off x="3926828" y="3526648"/>
            <a:ext cx="232360" cy="154082"/>
          </a:xfrm>
          <a:prstGeom prst="ellipse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56AC4AD-15DD-4696-B411-E31FE615807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002" t="35109" r="18182" b="51522"/>
          <a:stretch/>
        </p:blipFill>
        <p:spPr>
          <a:xfrm>
            <a:off x="3965911" y="3163141"/>
            <a:ext cx="154194" cy="154082"/>
          </a:xfrm>
          <a:prstGeom prst="ellipse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420CC44-1A0A-46BE-A03E-645DD14BD64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108" t="47728" r="-5860" b="35335"/>
          <a:stretch/>
        </p:blipFill>
        <p:spPr>
          <a:xfrm>
            <a:off x="3961455" y="2398086"/>
            <a:ext cx="226033" cy="195209"/>
          </a:xfrm>
          <a:prstGeom prst="ellipse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5F6C695-3CA1-49F8-A646-59BEB5F8021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192" t="15975" r="-2648" b="67087"/>
          <a:stretch/>
        </p:blipFill>
        <p:spPr>
          <a:xfrm>
            <a:off x="3934785" y="2069624"/>
            <a:ext cx="246581" cy="195209"/>
          </a:xfrm>
          <a:prstGeom prst="ellipse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AEEB5FE-12DC-4479-8A9A-EDA63F0A80D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876" b="84818"/>
          <a:stretch/>
        </p:blipFill>
        <p:spPr>
          <a:xfrm>
            <a:off x="3944717" y="2778749"/>
            <a:ext cx="232360" cy="174967"/>
          </a:xfrm>
          <a:prstGeom prst="ellipse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046977C-27C2-46D3-9B5D-F792C20898A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876" t="84140" b="2491"/>
          <a:stretch/>
        </p:blipFill>
        <p:spPr>
          <a:xfrm>
            <a:off x="3926828" y="3904285"/>
            <a:ext cx="232360" cy="154082"/>
          </a:xfrm>
          <a:prstGeom prst="ellipse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619A15EF-2A4E-48E9-B6C6-F47CB7B9C2F5}"/>
              </a:ext>
            </a:extLst>
          </p:cNvPr>
          <p:cNvSpPr/>
          <p:nvPr/>
        </p:nvSpPr>
        <p:spPr>
          <a:xfrm>
            <a:off x="3916893" y="4833217"/>
            <a:ext cx="182880" cy="182880"/>
          </a:xfrm>
          <a:prstGeom prst="rect">
            <a:avLst/>
          </a:prstGeom>
          <a:solidFill>
            <a:srgbClr val="FFA500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007612-4BFB-4116-AF24-1EA94602F626}"/>
              </a:ext>
            </a:extLst>
          </p:cNvPr>
          <p:cNvSpPr txBox="1"/>
          <p:nvPr/>
        </p:nvSpPr>
        <p:spPr>
          <a:xfrm>
            <a:off x="4297680" y="4686300"/>
            <a:ext cx="2560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Known regions associated with constitutional disorder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3B55A1B-5CBB-4950-B50B-A6FEDA4AA56D}"/>
              </a:ext>
            </a:extLst>
          </p:cNvPr>
          <p:cNvSpPr txBox="1"/>
          <p:nvPr/>
        </p:nvSpPr>
        <p:spPr>
          <a:xfrm rot="20689919">
            <a:off x="1391541" y="3637018"/>
            <a:ext cx="234440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b">
            <a:spAutoFit/>
          </a:bodyPr>
          <a:lstStyle/>
          <a:p>
            <a:pPr algn="ctr"/>
            <a:r>
              <a:rPr lang="en-US" sz="700"/>
              <a:t>X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BC8695-52A2-470C-897E-4452081D4881}"/>
              </a:ext>
            </a:extLst>
          </p:cNvPr>
          <p:cNvSpPr txBox="1"/>
          <p:nvPr/>
        </p:nvSpPr>
        <p:spPr>
          <a:xfrm rot="21344459">
            <a:off x="1720942" y="3561652"/>
            <a:ext cx="234440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b">
            <a:spAutoFit/>
          </a:bodyPr>
          <a:lstStyle/>
          <a:p>
            <a:pPr algn="ctr"/>
            <a:r>
              <a:rPr lang="en-US" sz="700"/>
              <a:t>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B7FDD8-B3F8-4902-BDEF-8079F59290CB}"/>
              </a:ext>
            </a:extLst>
          </p:cNvPr>
          <p:cNvSpPr txBox="1"/>
          <p:nvPr/>
        </p:nvSpPr>
        <p:spPr>
          <a:xfrm rot="20689919">
            <a:off x="1324627" y="244228"/>
            <a:ext cx="234440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b">
            <a:spAutoFit/>
          </a:bodyPr>
          <a:lstStyle/>
          <a:p>
            <a:pPr algn="ctr"/>
            <a:r>
              <a:rPr lang="en-US" sz="700"/>
              <a:t>X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75786AE-7090-4085-A839-18AF894A6DBB}"/>
              </a:ext>
            </a:extLst>
          </p:cNvPr>
          <p:cNvSpPr txBox="1"/>
          <p:nvPr/>
        </p:nvSpPr>
        <p:spPr>
          <a:xfrm rot="21344459">
            <a:off x="1654028" y="168862"/>
            <a:ext cx="234440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b">
            <a:spAutoFit/>
          </a:bodyPr>
          <a:lstStyle/>
          <a:p>
            <a:pPr algn="ctr"/>
            <a:r>
              <a:rPr lang="en-US" sz="700"/>
              <a:t>Y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73D20F-6BE9-46BE-B7AD-86A7044605F4}"/>
              </a:ext>
            </a:extLst>
          </p:cNvPr>
          <p:cNvSpPr txBox="1"/>
          <p:nvPr/>
        </p:nvSpPr>
        <p:spPr>
          <a:xfrm>
            <a:off x="289983" y="151884"/>
            <a:ext cx="410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Gotham Light" pitchFamily="2" charset="0"/>
              </a:rPr>
              <a:t>C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9879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080993487106C48AF58DDEF95D72879" ma:contentTypeVersion="17" ma:contentTypeDescription="Create a new document." ma:contentTypeScope="" ma:versionID="a7296b9f4301bb64b6683a00e7e0aa2b">
  <xsd:schema xmlns:xsd="http://www.w3.org/2001/XMLSchema" xmlns:xs="http://www.w3.org/2001/XMLSchema" xmlns:p="http://schemas.microsoft.com/office/2006/metadata/properties" xmlns:ns2="17ad48cb-924a-4ad2-b63e-557a9dc1d180" xmlns:ns3="35fa4d3d-72ea-4ff4-b9f3-de83ca151370" targetNamespace="http://schemas.microsoft.com/office/2006/metadata/properties" ma:root="true" ma:fieldsID="358ec9f03750049b9d40b2468cfa2c66" ns2:_="" ns3:_="">
    <xsd:import namespace="17ad48cb-924a-4ad2-b63e-557a9dc1d180"/>
    <xsd:import namespace="35fa4d3d-72ea-4ff4-b9f3-de83ca15137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7ad48cb-924a-4ad2-b63e-557a9dc1d18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088e7e2f-d067-4d7f-bc3a-669ef235ae6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fa4d3d-72ea-4ff4-b9f3-de83ca151370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b394af82-1a90-49dd-a3de-d2dd7af22dd0}" ma:internalName="TaxCatchAll" ma:showField="CatchAllData" ma:web="35fa4d3d-72ea-4ff4-b9f3-de83ca15137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7ad48cb-924a-4ad2-b63e-557a9dc1d180">
      <Terms xmlns="http://schemas.microsoft.com/office/infopath/2007/PartnerControls"/>
    </lcf76f155ced4ddcb4097134ff3c332f>
    <TaxCatchAll xmlns="35fa4d3d-72ea-4ff4-b9f3-de83ca151370" xsi:nil="true"/>
  </documentManagement>
</p:properties>
</file>

<file path=customXml/itemProps1.xml><?xml version="1.0" encoding="utf-8"?>
<ds:datastoreItem xmlns:ds="http://schemas.openxmlformats.org/officeDocument/2006/customXml" ds:itemID="{BADDC446-2683-495C-A8B3-AEC112B4D190}"/>
</file>

<file path=customXml/itemProps2.xml><?xml version="1.0" encoding="utf-8"?>
<ds:datastoreItem xmlns:ds="http://schemas.openxmlformats.org/officeDocument/2006/customXml" ds:itemID="{8397DC33-073B-4D20-B0E2-E3C95747D1D1}"/>
</file>

<file path=customXml/itemProps3.xml><?xml version="1.0" encoding="utf-8"?>
<ds:datastoreItem xmlns:ds="http://schemas.openxmlformats.org/officeDocument/2006/customXml" ds:itemID="{0A35231C-A8DC-4141-A15D-8932FC55E563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85</Words>
  <Application>Microsoft Office PowerPoint</Application>
  <PresentationFormat>On-screen Show (4:3)</PresentationFormat>
  <Paragraphs>3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Gotham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y Pang</dc:creator>
  <cp:lastModifiedBy>Hayk Barseghyan</cp:lastModifiedBy>
  <cp:revision>8</cp:revision>
  <dcterms:created xsi:type="dcterms:W3CDTF">2021-05-19T14:28:04Z</dcterms:created>
  <dcterms:modified xsi:type="dcterms:W3CDTF">2021-12-22T20:53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080993487106C48AF58DDEF95D72879</vt:lpwstr>
  </property>
</Properties>
</file>